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11"/>
  </p:notesMasterIdLst>
  <p:sldIdLst>
    <p:sldId id="265" r:id="rId2"/>
    <p:sldId id="266" r:id="rId3"/>
    <p:sldId id="267" r:id="rId4"/>
    <p:sldId id="271" r:id="rId5"/>
    <p:sldId id="270" r:id="rId6"/>
    <p:sldId id="258" r:id="rId7"/>
    <p:sldId id="261" r:id="rId8"/>
    <p:sldId id="256" r:id="rId9"/>
    <p:sldId id="269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160" userDrawn="1">
          <p15:clr>
            <a:srgbClr val="A4A3A4"/>
          </p15:clr>
        </p15:guide>
        <p15:guide id="3" orient="horz" pos="312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5BC643A-D958-8346-546D-9BDFCC97553C}" name="Varrelmann, Mark" initials="MV" userId="S::Varrelmann@ifz-goettingen.de::63434856-3d06-451b-9a4f-5bbf46ecbb6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43" autoAdjust="0"/>
    <p:restoredTop sz="93364" autoAdjust="0"/>
  </p:normalViewPr>
  <p:slideViewPr>
    <p:cSldViewPr snapToGrid="0" showGuides="1">
      <p:cViewPr varScale="1">
        <p:scale>
          <a:sx n="73" d="100"/>
          <a:sy n="73" d="100"/>
        </p:scale>
        <p:origin x="3564" y="102"/>
      </p:cViewPr>
      <p:guideLst>
        <p:guide pos="2160"/>
        <p:guide orient="horz" pos="312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A04B63-54C2-49D3-908C-DD7363C7D2AB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A89890-0622-4B10-934A-936DDFF1F7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8409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A89890-0622-4B10-934A-936DDFF1F74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92832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2028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7644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3058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1713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056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0898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8699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13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5450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851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0099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28FDF-0931-40AC-9DCE-3C4CDD03116A}" type="datetimeFigureOut">
              <a:rPr lang="en-GB" smtClean="0"/>
              <a:t>2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341BF-4F7F-4DB6-A7A4-AE58CA7E1E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4595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5.wdp"/><Relationship Id="rId18" Type="http://schemas.microsoft.com/office/2007/relationships/hdphoto" Target="../media/hdphoto7.wdp"/><Relationship Id="rId26" Type="http://schemas.microsoft.com/office/2007/relationships/hdphoto" Target="../media/hdphoto11.wdp"/><Relationship Id="rId3" Type="http://schemas.openxmlformats.org/officeDocument/2006/relationships/image" Target="../media/image1.png"/><Relationship Id="rId21" Type="http://schemas.openxmlformats.org/officeDocument/2006/relationships/image" Target="../media/image11.png"/><Relationship Id="rId34" Type="http://schemas.openxmlformats.org/officeDocument/2006/relationships/image" Target="../media/image20.jpeg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17" Type="http://schemas.openxmlformats.org/officeDocument/2006/relationships/image" Target="../media/image9.png"/><Relationship Id="rId25" Type="http://schemas.openxmlformats.org/officeDocument/2006/relationships/image" Target="../media/image13.png"/><Relationship Id="rId33" Type="http://schemas.openxmlformats.org/officeDocument/2006/relationships/image" Target="../media/image19.jpeg"/><Relationship Id="rId2" Type="http://schemas.openxmlformats.org/officeDocument/2006/relationships/notesSlide" Target="../notesSlides/notesSlide1.xml"/><Relationship Id="rId16" Type="http://schemas.microsoft.com/office/2007/relationships/hdphoto" Target="../media/hdphoto6.wdp"/><Relationship Id="rId20" Type="http://schemas.microsoft.com/office/2007/relationships/hdphoto" Target="../media/hdphoto8.wdp"/><Relationship Id="rId29" Type="http://schemas.microsoft.com/office/2007/relationships/hdphoto" Target="../media/hdphoto1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24" Type="http://schemas.microsoft.com/office/2007/relationships/hdphoto" Target="../media/hdphoto10.wdp"/><Relationship Id="rId32" Type="http://schemas.openxmlformats.org/officeDocument/2006/relationships/image" Target="../media/image18.jpeg"/><Relationship Id="rId5" Type="http://schemas.openxmlformats.org/officeDocument/2006/relationships/image" Target="../media/image2.jpeg"/><Relationship Id="rId15" Type="http://schemas.openxmlformats.org/officeDocument/2006/relationships/image" Target="../media/image8.png"/><Relationship Id="rId23" Type="http://schemas.openxmlformats.org/officeDocument/2006/relationships/image" Target="../media/image12.png"/><Relationship Id="rId28" Type="http://schemas.openxmlformats.org/officeDocument/2006/relationships/image" Target="../media/image15.png"/><Relationship Id="rId10" Type="http://schemas.openxmlformats.org/officeDocument/2006/relationships/image" Target="../media/image5.png"/><Relationship Id="rId19" Type="http://schemas.openxmlformats.org/officeDocument/2006/relationships/image" Target="../media/image10.png"/><Relationship Id="rId31" Type="http://schemas.openxmlformats.org/officeDocument/2006/relationships/image" Target="../media/image17.png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openxmlformats.org/officeDocument/2006/relationships/image" Target="../media/image7.png"/><Relationship Id="rId22" Type="http://schemas.microsoft.com/office/2007/relationships/hdphoto" Target="../media/hdphoto9.wdp"/><Relationship Id="rId27" Type="http://schemas.openxmlformats.org/officeDocument/2006/relationships/image" Target="../media/image14.jpeg"/><Relationship Id="rId30" Type="http://schemas.openxmlformats.org/officeDocument/2006/relationships/image" Target="../media/image16.png"/><Relationship Id="rId35" Type="http://schemas.openxmlformats.org/officeDocument/2006/relationships/image" Target="../media/image21.jpeg"/><Relationship Id="rId8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7" Type="http://schemas.openxmlformats.org/officeDocument/2006/relationships/image" Target="../media/image56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4" Type="http://schemas.openxmlformats.org/officeDocument/2006/relationships/image" Target="../media/image4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701753" y="313331"/>
            <a:ext cx="2506578" cy="2358608"/>
            <a:chOff x="1365424" y="821991"/>
            <a:chExt cx="3605897" cy="3052169"/>
          </a:xfrm>
        </p:grpSpPr>
        <p:grpSp>
          <p:nvGrpSpPr>
            <p:cNvPr id="4" name="Group 3"/>
            <p:cNvGrpSpPr/>
            <p:nvPr/>
          </p:nvGrpSpPr>
          <p:grpSpPr>
            <a:xfrm>
              <a:off x="1476605" y="821991"/>
              <a:ext cx="3391086" cy="2454748"/>
              <a:chOff x="2641655" y="624305"/>
              <a:chExt cx="3969336" cy="3769429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3" cstate="screen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1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623927" y="624306"/>
                <a:ext cx="1987063" cy="1873374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5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646160" y="624305"/>
                <a:ext cx="1977767" cy="1893852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6" cstate="screen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1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641655" y="2495937"/>
                <a:ext cx="1982266" cy="1897797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8" cstate="screen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637723" y="2497678"/>
                <a:ext cx="1973268" cy="1896056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</p:grpSp>
        <p:sp>
          <p:nvSpPr>
            <p:cNvPr id="5" name="TextBox 4"/>
            <p:cNvSpPr txBox="1"/>
            <p:nvPr/>
          </p:nvSpPr>
          <p:spPr>
            <a:xfrm>
              <a:off x="1365424" y="3276740"/>
              <a:ext cx="3605897" cy="5974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eaf color</a:t>
              </a:r>
            </a:p>
            <a:p>
              <a:pPr algn="ctr"/>
              <a:r>
                <a:rPr lang="de-DE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. Light </a:t>
              </a:r>
              <a:r>
                <a:rPr lang="de-DE" sz="100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green</a:t>
              </a:r>
              <a:r>
                <a:rPr lang="de-DE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; 2. Green; 3. </a:t>
              </a:r>
              <a:r>
                <a:rPr lang="de-DE" sz="100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Red</a:t>
              </a:r>
              <a:r>
                <a:rPr lang="de-DE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; 4. Mixed</a:t>
              </a:r>
              <a:endParaRPr lang="en-GB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46812" y="1742235"/>
              <a:ext cx="398324" cy="321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545107" y="1742235"/>
              <a:ext cx="398324" cy="321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2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33897" y="2971740"/>
              <a:ext cx="398324" cy="321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4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841123" y="2979889"/>
              <a:ext cx="398324" cy="321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3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5F4CE5DA-7B13-F5D4-F658-BE9AAC07C85F}"/>
              </a:ext>
            </a:extLst>
          </p:cNvPr>
          <p:cNvGrpSpPr/>
          <p:nvPr/>
        </p:nvGrpSpPr>
        <p:grpSpPr>
          <a:xfrm>
            <a:off x="4384103" y="4576770"/>
            <a:ext cx="1705315" cy="1229314"/>
            <a:chOff x="8742706" y="695248"/>
            <a:chExt cx="2947149" cy="1817158"/>
          </a:xfrm>
        </p:grpSpPr>
        <p:pic>
          <p:nvPicPr>
            <p:cNvPr id="27" name="Picture 26" descr="A black background with a few small objects&#10;&#10;Description automatically generated with medium confidence">
              <a:extLst>
                <a:ext uri="{FF2B5EF4-FFF2-40B4-BE49-F238E27FC236}">
                  <a16:creationId xmlns:a16="http://schemas.microsoft.com/office/drawing/2014/main" id="{765F0E53-791C-E0AE-A618-1A91B26E7F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screen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3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9211978" y="225976"/>
              <a:ext cx="1817158" cy="2755701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81679AC-58B9-3714-75A1-084DD185A3B0}"/>
                </a:ext>
              </a:extLst>
            </p:cNvPr>
            <p:cNvSpPr txBox="1"/>
            <p:nvPr/>
          </p:nvSpPr>
          <p:spPr>
            <a:xfrm>
              <a:off x="8985456" y="1550535"/>
              <a:ext cx="2704399" cy="4549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Monogerm seeds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AAE86B6-C203-0CF6-7143-12E536CA62AB}"/>
                </a:ext>
              </a:extLst>
            </p:cNvPr>
            <p:cNvSpPr txBox="1"/>
            <p:nvPr/>
          </p:nvSpPr>
          <p:spPr>
            <a:xfrm>
              <a:off x="8985176" y="697650"/>
              <a:ext cx="2590814" cy="4549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Multigerm seeds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701753" y="2726338"/>
            <a:ext cx="2506578" cy="1696658"/>
            <a:chOff x="701753" y="2813866"/>
            <a:chExt cx="2506578" cy="1696658"/>
          </a:xfrm>
        </p:grpSpPr>
        <p:grpSp>
          <p:nvGrpSpPr>
            <p:cNvPr id="57" name="Group 56"/>
            <p:cNvGrpSpPr/>
            <p:nvPr/>
          </p:nvGrpSpPr>
          <p:grpSpPr>
            <a:xfrm>
              <a:off x="701753" y="2813866"/>
              <a:ext cx="2506578" cy="1696658"/>
              <a:chOff x="-1" y="4970212"/>
              <a:chExt cx="3112607" cy="2241810"/>
            </a:xfrm>
          </p:grpSpPr>
          <p:grpSp>
            <p:nvGrpSpPr>
              <p:cNvPr id="46" name="Group 45"/>
              <p:cNvGrpSpPr/>
              <p:nvPr/>
            </p:nvGrpSpPr>
            <p:grpSpPr>
              <a:xfrm>
                <a:off x="91715" y="4970212"/>
                <a:ext cx="2931436" cy="1609089"/>
                <a:chOff x="91715" y="5630612"/>
                <a:chExt cx="2931436" cy="1609089"/>
              </a:xfrm>
            </p:grpSpPr>
            <p:pic>
              <p:nvPicPr>
                <p:cNvPr id="30" name="Picture 29"/>
                <p:cNvPicPr>
                  <a:picLocks noChangeAspect="1"/>
                </p:cNvPicPr>
                <p:nvPr/>
              </p:nvPicPr>
              <p:blipFill rotWithShape="1">
                <a:blip r:embed="rId12" cstate="screen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bright="-17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500967" y="5630613"/>
                  <a:ext cx="1522184" cy="1609088"/>
                </a:xfrm>
                <a:prstGeom prst="rect">
                  <a:avLst/>
                </a:prstGeom>
                <a:ln>
                  <a:solidFill>
                    <a:schemeClr val="accent2">
                      <a:lumMod val="75000"/>
                    </a:schemeClr>
                  </a:solidFill>
                </a:ln>
              </p:spPr>
            </p:pic>
            <p:pic>
              <p:nvPicPr>
                <p:cNvPr id="32" name="Picture 31"/>
                <p:cNvPicPr>
                  <a:picLocks noChangeAspect="1"/>
                </p:cNvPicPr>
                <p:nvPr/>
              </p:nvPicPr>
              <p:blipFill rotWithShape="1">
                <a:blip r:embed="rId14" cstate="screen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91715" y="5630612"/>
                  <a:ext cx="1476254" cy="1609087"/>
                </a:xfrm>
                <a:prstGeom prst="rect">
                  <a:avLst/>
                </a:prstGeom>
                <a:ln>
                  <a:solidFill>
                    <a:schemeClr val="accent2">
                      <a:lumMod val="75000"/>
                    </a:schemeClr>
                  </a:solidFill>
                </a:ln>
              </p:spPr>
            </p:pic>
          </p:grpSp>
          <p:sp>
            <p:nvSpPr>
              <p:cNvPr id="56" name="TextBox 55"/>
              <p:cNvSpPr txBox="1"/>
              <p:nvPr/>
            </p:nvSpPr>
            <p:spPr>
              <a:xfrm>
                <a:off x="-1" y="6602020"/>
                <a:ext cx="3112607" cy="6100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Flesh color</a:t>
                </a:r>
              </a:p>
              <a:p>
                <a:pPr algn="ctr"/>
                <a:r>
                  <a:rPr lang="de-DE" sz="100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1. White; 2. </a:t>
                </a:r>
                <a:r>
                  <a:rPr lang="de-DE" sz="1000" dirty="0" err="1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Red</a:t>
                </a:r>
                <a:endParaRPr lang="en-GB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</p:grpSp>
        <p:sp>
          <p:nvSpPr>
            <p:cNvPr id="47" name="TextBox 46"/>
            <p:cNvSpPr txBox="1"/>
            <p:nvPr/>
          </p:nvSpPr>
          <p:spPr>
            <a:xfrm>
              <a:off x="1728049" y="3802885"/>
              <a:ext cx="279328" cy="26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18991" y="3802885"/>
              <a:ext cx="279328" cy="26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2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3198726" y="303110"/>
            <a:ext cx="3182341" cy="2372055"/>
            <a:chOff x="3066267" y="1730615"/>
            <a:chExt cx="3951753" cy="3092873"/>
          </a:xfrm>
        </p:grpSpPr>
        <p:grpSp>
          <p:nvGrpSpPr>
            <p:cNvPr id="14" name="Group 13"/>
            <p:cNvGrpSpPr/>
            <p:nvPr/>
          </p:nvGrpSpPr>
          <p:grpSpPr>
            <a:xfrm>
              <a:off x="3066267" y="1730615"/>
              <a:ext cx="3951753" cy="3092873"/>
              <a:chOff x="7530549" y="3748204"/>
              <a:chExt cx="3605897" cy="3071606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7530549" y="3748204"/>
                <a:ext cx="3605897" cy="3071606"/>
                <a:chOff x="7530549" y="3748204"/>
                <a:chExt cx="3605897" cy="3071606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>
                  <a:off x="7530549" y="6221994"/>
                  <a:ext cx="3605897" cy="5978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400" b="1" dirty="0" err="1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Petiole</a:t>
                  </a:r>
                  <a:r>
                    <a:rPr lang="de-DE" sz="1400" b="1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 color </a:t>
                  </a:r>
                  <a:endParaRPr lang="de-DE" sz="1000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endParaRPr>
                </a:p>
                <a:p>
                  <a:pPr algn="ctr"/>
                  <a:r>
                    <a:rPr lang="de-DE" sz="1000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1. </a:t>
                  </a:r>
                  <a:r>
                    <a:rPr lang="de-DE" sz="1000" dirty="0" err="1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Red</a:t>
                  </a:r>
                  <a:r>
                    <a:rPr lang="de-DE" sz="1000" dirty="0"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; 2. Green; 3. White; 4. Yellow</a:t>
                  </a:r>
                  <a:endParaRPr lang="en-GB" sz="100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endParaRPr>
                </a:p>
              </p:txBody>
            </p:sp>
            <p:grpSp>
              <p:nvGrpSpPr>
                <p:cNvPr id="18" name="Group 17"/>
                <p:cNvGrpSpPr/>
                <p:nvPr/>
              </p:nvGrpSpPr>
              <p:grpSpPr>
                <a:xfrm>
                  <a:off x="7824788" y="3748204"/>
                  <a:ext cx="2824162" cy="2490672"/>
                  <a:chOff x="7824788" y="3748204"/>
                  <a:chExt cx="2824162" cy="2490672"/>
                </a:xfrm>
              </p:grpSpPr>
              <p:pic>
                <p:nvPicPr>
                  <p:cNvPr id="25" name="Picture 24"/>
                  <p:cNvPicPr>
                    <a:picLocks noChangeAspect="1"/>
                  </p:cNvPicPr>
                  <p:nvPr/>
                </p:nvPicPr>
                <p:blipFill rotWithShape="1">
                  <a:blip r:embed="rId15" cstate="screen">
                    <a:extLst>
                      <a:ext uri="{BEBA8EAE-BF5A-486C-A8C5-ECC9F3942E4B}">
                        <a14:imgProps xmlns:a14="http://schemas.microsoft.com/office/drawing/2010/main">
                          <a14:imgLayer r:embed="rId16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9927888" y="3748204"/>
                    <a:ext cx="721062" cy="2476596"/>
                  </a:xfrm>
                  <a:prstGeom prst="rect">
                    <a:avLst/>
                  </a:prstGeom>
                  <a:ln>
                    <a:solidFill>
                      <a:schemeClr val="accent2">
                        <a:lumMod val="75000"/>
                      </a:schemeClr>
                    </a:solidFill>
                  </a:ln>
                </p:spPr>
              </p:pic>
              <p:pic>
                <p:nvPicPr>
                  <p:cNvPr id="22" name="Picture 21"/>
                  <p:cNvPicPr>
                    <a:picLocks noChangeAspect="1"/>
                  </p:cNvPicPr>
                  <p:nvPr/>
                </p:nvPicPr>
                <p:blipFill rotWithShape="1">
                  <a:blip r:embed="rId17" cstate="screen">
                    <a:extLst>
                      <a:ext uri="{BEBA8EAE-BF5A-486C-A8C5-ECC9F3942E4B}">
                        <a14:imgProps xmlns:a14="http://schemas.microsoft.com/office/drawing/2010/main">
                          <a14:imgLayer r:embed="rId18">
                            <a14:imgEffect>
                              <a14:brightnessContrast bright="9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7824788" y="3753910"/>
                    <a:ext cx="2103100" cy="2470597"/>
                  </a:xfrm>
                  <a:prstGeom prst="rect">
                    <a:avLst/>
                  </a:prstGeom>
                  <a:ln>
                    <a:solidFill>
                      <a:schemeClr val="accent2">
                        <a:lumMod val="75000"/>
                      </a:schemeClr>
                    </a:solidFill>
                  </a:ln>
                </p:spPr>
              </p:pic>
              <p:cxnSp>
                <p:nvCxnSpPr>
                  <p:cNvPr id="24" name="Straight Connector 23"/>
                  <p:cNvCxnSpPr/>
                  <p:nvPr/>
                </p:nvCxnSpPr>
                <p:spPr>
                  <a:xfrm>
                    <a:off x="9370091" y="3748204"/>
                    <a:ext cx="2523" cy="2490672"/>
                  </a:xfrm>
                  <a:prstGeom prst="line">
                    <a:avLst/>
                  </a:prstGeom>
                  <a:ln w="12700">
                    <a:solidFill>
                      <a:schemeClr val="accent2">
                        <a:lumMod val="75000"/>
                      </a:schemeClr>
                    </a:solidFill>
                  </a:ln>
                </p:spPr>
                <p:style>
                  <a:lnRef idx="1">
                    <a:schemeClr val="accent4"/>
                  </a:lnRef>
                  <a:fillRef idx="0">
                    <a:schemeClr val="accent4"/>
                  </a:fillRef>
                  <a:effectRef idx="0">
                    <a:schemeClr val="accent4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" name="TextBox 18"/>
                <p:cNvSpPr txBox="1"/>
                <p:nvPr/>
              </p:nvSpPr>
              <p:spPr>
                <a:xfrm>
                  <a:off x="8257868" y="5937210"/>
                  <a:ext cx="398325" cy="3267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37" dirty="0">
                      <a:solidFill>
                        <a:schemeClr val="bg1"/>
                      </a:solidFill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1</a:t>
                  </a:r>
                  <a:endParaRPr lang="en-GB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9111013" y="5937210"/>
                  <a:ext cx="398325" cy="3267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37" dirty="0">
                      <a:solidFill>
                        <a:schemeClr val="bg1"/>
                      </a:solidFill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2</a:t>
                  </a:r>
                  <a:endParaRPr lang="en-GB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9688795" y="5937210"/>
                  <a:ext cx="398325" cy="3267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37" dirty="0">
                      <a:solidFill>
                        <a:schemeClr val="bg1"/>
                      </a:solidFill>
                      <a:latin typeface="Microsoft Sans Serif" panose="020B0604020202020204" pitchFamily="34" charset="0"/>
                      <a:ea typeface="Microsoft Sans Serif" panose="020B0604020202020204" pitchFamily="34" charset="0"/>
                      <a:cs typeface="Microsoft Sans Serif" panose="020B0604020202020204" pitchFamily="34" charset="0"/>
                    </a:rPr>
                    <a:t>3</a:t>
                  </a:r>
                  <a:endParaRPr lang="en-GB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endParaRPr>
                </a:p>
              </p:txBody>
            </p:sp>
          </p:grpSp>
          <p:sp>
            <p:nvSpPr>
              <p:cNvPr id="16" name="TextBox 15"/>
              <p:cNvSpPr txBox="1"/>
              <p:nvPr/>
            </p:nvSpPr>
            <p:spPr>
              <a:xfrm>
                <a:off x="10399147" y="5918676"/>
                <a:ext cx="398325" cy="3267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4</a:t>
                </a:r>
                <a:endParaRPr lang="en-GB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</p:grpSp>
        <p:cxnSp>
          <p:nvCxnSpPr>
            <p:cNvPr id="54" name="Straight Connector 53"/>
            <p:cNvCxnSpPr/>
            <p:nvPr/>
          </p:nvCxnSpPr>
          <p:spPr>
            <a:xfrm>
              <a:off x="4133299" y="1731020"/>
              <a:ext cx="2765" cy="2507917"/>
            </a:xfrm>
            <a:prstGeom prst="line">
              <a:avLst/>
            </a:prstGeom>
            <a:ln w="12700"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</p:grpSp>
      <p:sp>
        <p:nvSpPr>
          <p:cNvPr id="61" name="Oval 60"/>
          <p:cNvSpPr/>
          <p:nvPr/>
        </p:nvSpPr>
        <p:spPr>
          <a:xfrm>
            <a:off x="5062923" y="3748703"/>
            <a:ext cx="485189" cy="121593"/>
          </a:xfrm>
          <a:prstGeom prst="ellipse">
            <a:avLst/>
          </a:prstGeom>
          <a:noFill/>
          <a:ln w="19050"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514">
              <a:latin typeface="Microsoft Sans Serif" panose="020B0604020202020204" pitchFamily="34" charset="0"/>
              <a:ea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62" name="Oval 61"/>
          <p:cNvSpPr/>
          <p:nvPr/>
        </p:nvSpPr>
        <p:spPr>
          <a:xfrm>
            <a:off x="3830981" y="3782096"/>
            <a:ext cx="485189" cy="88198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514">
              <a:latin typeface="Microsoft Sans Serif" panose="020B0604020202020204" pitchFamily="34" charset="0"/>
              <a:ea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3450993" y="2726336"/>
            <a:ext cx="2547753" cy="1698751"/>
            <a:chOff x="3450993" y="2813864"/>
            <a:chExt cx="2547753" cy="1698751"/>
          </a:xfrm>
        </p:grpSpPr>
        <p:grpSp>
          <p:nvGrpSpPr>
            <p:cNvPr id="2" name="Group 1"/>
            <p:cNvGrpSpPr/>
            <p:nvPr/>
          </p:nvGrpSpPr>
          <p:grpSpPr>
            <a:xfrm>
              <a:off x="3450993" y="2813864"/>
              <a:ext cx="2496050" cy="1698751"/>
              <a:chOff x="3429000" y="2900707"/>
              <a:chExt cx="2518043" cy="1823480"/>
            </a:xfrm>
          </p:grpSpPr>
          <p:grpSp>
            <p:nvGrpSpPr>
              <p:cNvPr id="45" name="Group 44"/>
              <p:cNvGrpSpPr/>
              <p:nvPr/>
            </p:nvGrpSpPr>
            <p:grpSpPr>
              <a:xfrm>
                <a:off x="3429000" y="2900707"/>
                <a:ext cx="2518043" cy="1307213"/>
                <a:chOff x="3384234" y="5630611"/>
                <a:chExt cx="3099533" cy="1609087"/>
              </a:xfrm>
            </p:grpSpPr>
            <p:pic>
              <p:nvPicPr>
                <p:cNvPr id="33" name="Picture 32"/>
                <p:cNvPicPr>
                  <a:picLocks noChangeAspect="1"/>
                </p:cNvPicPr>
                <p:nvPr/>
              </p:nvPicPr>
              <p:blipFill rotWithShape="1">
                <a:blip r:embed="rId19" cstate="screen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bright="-1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384234" y="5630612"/>
                  <a:ext cx="1562416" cy="1606380"/>
                </a:xfrm>
                <a:prstGeom prst="rect">
                  <a:avLst/>
                </a:prstGeom>
                <a:ln>
                  <a:solidFill>
                    <a:schemeClr val="accent2">
                      <a:lumMod val="75000"/>
                    </a:schemeClr>
                  </a:solidFill>
                </a:ln>
              </p:spPr>
            </p:pic>
            <p:pic>
              <p:nvPicPr>
                <p:cNvPr id="34" name="Picture 33"/>
                <p:cNvPicPr>
                  <a:picLocks noChangeAspect="1"/>
                </p:cNvPicPr>
                <p:nvPr/>
              </p:nvPicPr>
              <p:blipFill rotWithShape="1">
                <a:blip r:embed="rId21" cstate="screen">
                  <a:extLst>
                    <a:ext uri="{BEBA8EAE-BF5A-486C-A8C5-ECC9F3942E4B}">
                      <a14:imgProps xmlns:a14="http://schemas.microsoft.com/office/drawing/2010/main">
                        <a14:imgLayer r:embed="rId22">
                          <a14:imgEffect>
                            <a14:brightnessContrast bright="-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947236" y="5630611"/>
                  <a:ext cx="1536531" cy="1609087"/>
                </a:xfrm>
                <a:prstGeom prst="rect">
                  <a:avLst/>
                </a:prstGeom>
                <a:ln>
                  <a:solidFill>
                    <a:schemeClr val="accent2">
                      <a:lumMod val="75000"/>
                    </a:schemeClr>
                  </a:solidFill>
                </a:ln>
              </p:spPr>
            </p:pic>
          </p:grpSp>
          <p:sp>
            <p:nvSpPr>
              <p:cNvPr id="58" name="TextBox 57"/>
              <p:cNvSpPr txBox="1"/>
              <p:nvPr/>
            </p:nvSpPr>
            <p:spPr>
              <a:xfrm>
                <a:off x="3429000" y="4228625"/>
                <a:ext cx="2518042" cy="4955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b="1" dirty="0" err="1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Cambium</a:t>
                </a:r>
                <a:r>
                  <a:rPr lang="de-DE" sz="1400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 ring color</a:t>
                </a:r>
              </a:p>
              <a:p>
                <a:pPr algn="ctr"/>
                <a:r>
                  <a:rPr lang="de-DE" sz="100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1. </a:t>
                </a:r>
                <a:r>
                  <a:rPr lang="de-DE" sz="1000" dirty="0" err="1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Red</a:t>
                </a:r>
                <a:r>
                  <a:rPr lang="de-DE" sz="100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; 2. White</a:t>
                </a:r>
                <a:endParaRPr lang="en-GB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</p:grpSp>
        <p:sp>
          <p:nvSpPr>
            <p:cNvPr id="69" name="TextBox 68"/>
            <p:cNvSpPr txBox="1"/>
            <p:nvPr/>
          </p:nvSpPr>
          <p:spPr>
            <a:xfrm>
              <a:off x="4466572" y="3802883"/>
              <a:ext cx="279328" cy="26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719418" y="3802883"/>
              <a:ext cx="279328" cy="26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2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772255" y="4465054"/>
            <a:ext cx="3737443" cy="1611223"/>
            <a:chOff x="132458" y="10359964"/>
            <a:chExt cx="6702685" cy="3074620"/>
          </a:xfrm>
        </p:grpSpPr>
        <p:grpSp>
          <p:nvGrpSpPr>
            <p:cNvPr id="75" name="Group 74"/>
            <p:cNvGrpSpPr/>
            <p:nvPr/>
          </p:nvGrpSpPr>
          <p:grpSpPr>
            <a:xfrm>
              <a:off x="143401" y="10359964"/>
              <a:ext cx="6691742" cy="2234614"/>
              <a:chOff x="876300" y="7219502"/>
              <a:chExt cx="5576968" cy="1763198"/>
            </a:xfrm>
          </p:grpSpPr>
          <p:pic>
            <p:nvPicPr>
              <p:cNvPr id="64" name="Picture 63"/>
              <p:cNvPicPr>
                <a:picLocks noChangeAspect="1"/>
              </p:cNvPicPr>
              <p:nvPr/>
            </p:nvPicPr>
            <p:blipFill rotWithShape="1">
              <a:blip r:embed="rId23" cstate="screen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4779715" y="7420875"/>
                <a:ext cx="1720855" cy="1318114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  <p:pic>
            <p:nvPicPr>
              <p:cNvPr id="66" name="Picture 65"/>
              <p:cNvPicPr>
                <a:picLocks noChangeAspect="1"/>
              </p:cNvPicPr>
              <p:nvPr/>
            </p:nvPicPr>
            <p:blipFill rotWithShape="1">
              <a:blip r:embed="rId25" cstate="screen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brightnessContrast bright="1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2117733" y="7372821"/>
                <a:ext cx="1720855" cy="1414217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  <p:pic>
            <p:nvPicPr>
              <p:cNvPr id="67" name="Picture 66"/>
              <p:cNvPicPr>
                <a:picLocks noChangeAspect="1"/>
              </p:cNvPicPr>
              <p:nvPr/>
            </p:nvPicPr>
            <p:blipFill rotWithShape="1">
              <a:blip r:embed="rId27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3470128" y="7434643"/>
                <a:ext cx="1720856" cy="1290574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  <p:pic>
            <p:nvPicPr>
              <p:cNvPr id="68" name="Picture 67"/>
              <p:cNvPicPr>
                <a:picLocks noChangeAspect="1"/>
              </p:cNvPicPr>
              <p:nvPr/>
            </p:nvPicPr>
            <p:blipFill rotWithShape="1">
              <a:blip r:embed="rId28" cstate="screen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1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714759" y="7381045"/>
                <a:ext cx="1720854" cy="1397772"/>
              </a:xfrm>
              <a:prstGeom prst="rect">
                <a:avLst/>
              </a:prstGeom>
              <a:ln>
                <a:solidFill>
                  <a:schemeClr val="accent2">
                    <a:lumMod val="75000"/>
                  </a:schemeClr>
                </a:solidFill>
              </a:ln>
            </p:spPr>
          </p:pic>
          <p:sp>
            <p:nvSpPr>
              <p:cNvPr id="71" name="TextBox 70"/>
              <p:cNvSpPr txBox="1"/>
              <p:nvPr/>
            </p:nvSpPr>
            <p:spPr>
              <a:xfrm>
                <a:off x="1983344" y="8607733"/>
                <a:ext cx="436530" cy="3749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1</a:t>
                </a:r>
                <a:endParaRPr lang="en-GB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3370243" y="8607733"/>
                <a:ext cx="436530" cy="3749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2</a:t>
                </a:r>
                <a:endParaRPr lang="en-GB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4674329" y="8607733"/>
                <a:ext cx="436530" cy="3749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3</a:t>
                </a:r>
                <a:endParaRPr lang="en-GB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6016738" y="8607736"/>
                <a:ext cx="436530" cy="3749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37" dirty="0">
                    <a:solidFill>
                      <a:schemeClr val="bg1"/>
                    </a:solidFill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4</a:t>
                </a:r>
                <a:endParaRPr lang="en-GB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</p:grpSp>
        <p:sp>
          <p:nvSpPr>
            <p:cNvPr id="60" name="TextBox 59"/>
            <p:cNvSpPr txBox="1"/>
            <p:nvPr/>
          </p:nvSpPr>
          <p:spPr>
            <a:xfrm>
              <a:off x="132458" y="12553611"/>
              <a:ext cx="6517819" cy="8809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External</a:t>
              </a:r>
              <a:r>
                <a:rPr lang="de-DE" sz="1400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400" b="1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root</a:t>
              </a:r>
              <a:r>
                <a:rPr lang="de-DE" sz="1400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color</a:t>
              </a:r>
            </a:p>
            <a:p>
              <a:pPr algn="ctr"/>
              <a:r>
                <a:rPr lang="de-DE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. White; 2. Yellow; 3. Yellow-orange; 4. </a:t>
              </a:r>
              <a:r>
                <a:rPr lang="de-DE" sz="100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Red</a:t>
              </a:r>
              <a:endParaRPr lang="en-GB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</a:t>
            </a:r>
          </a:p>
        </p:txBody>
      </p:sp>
      <p:grpSp>
        <p:nvGrpSpPr>
          <p:cNvPr id="42" name="Group 41"/>
          <p:cNvGrpSpPr/>
          <p:nvPr/>
        </p:nvGrpSpPr>
        <p:grpSpPr>
          <a:xfrm>
            <a:off x="566285" y="7615818"/>
            <a:ext cx="3169727" cy="2026703"/>
            <a:chOff x="1770990" y="8076448"/>
            <a:chExt cx="3638159" cy="2287823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30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3992" t="228" r="-151" b="-228"/>
            <a:stretch/>
          </p:blipFill>
          <p:spPr>
            <a:xfrm>
              <a:off x="1996929" y="8076448"/>
              <a:ext cx="3412220" cy="1455759"/>
            </a:xfrm>
            <a:prstGeom prst="rect">
              <a:avLst/>
            </a:prstGeom>
          </p:spPr>
        </p:pic>
        <p:sp>
          <p:nvSpPr>
            <p:cNvPr id="77" name="TextBox 76"/>
            <p:cNvSpPr txBox="1"/>
            <p:nvPr/>
          </p:nvSpPr>
          <p:spPr>
            <a:xfrm>
              <a:off x="1991166" y="9532208"/>
              <a:ext cx="3417983" cy="832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. A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highly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resistant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ugar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beet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accession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(ASD290). </a:t>
              </a:r>
            </a:p>
            <a:p>
              <a:pPr algn="ctr"/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2. A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highly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usceptible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sugar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beet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accession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(ASD287),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photos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were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05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taken</a:t>
              </a:r>
              <a:r>
                <a:rPr lang="de-DE" sz="105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21 WAS</a:t>
              </a:r>
              <a:endParaRPr lang="en-GB" sz="105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  <a:p>
              <a:pPr algn="ctr"/>
              <a:endParaRPr lang="de-DE" sz="1137" b="1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770990" y="9261034"/>
              <a:ext cx="294639" cy="2673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641340" y="9261034"/>
              <a:ext cx="294639" cy="2869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37" dirty="0">
                  <a:solidFill>
                    <a:schemeClr val="bg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2</a:t>
              </a:r>
              <a:endParaRPr lang="en-GB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779039" y="6087386"/>
            <a:ext cx="5150163" cy="1351565"/>
            <a:chOff x="803012" y="6185738"/>
            <a:chExt cx="5150163" cy="1351565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3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03012" y="6185738"/>
              <a:ext cx="5150163" cy="1070265"/>
            </a:xfrm>
            <a:prstGeom prst="rect">
              <a:avLst/>
            </a:prstGeom>
          </p:spPr>
        </p:pic>
        <p:sp>
          <p:nvSpPr>
            <p:cNvPr id="36" name="Rectangle 35"/>
            <p:cNvSpPr/>
            <p:nvPr/>
          </p:nvSpPr>
          <p:spPr>
            <a:xfrm>
              <a:off x="809439" y="7229526"/>
              <a:ext cx="5137308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GB" sz="1400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Cercospora leaf spot incidence</a:t>
              </a:r>
            </a:p>
          </p:txBody>
        </p:sp>
      </p:grpSp>
      <p:sp>
        <p:nvSpPr>
          <p:cNvPr id="81" name="TextBox 80"/>
          <p:cNvSpPr txBox="1"/>
          <p:nvPr/>
        </p:nvSpPr>
        <p:spPr>
          <a:xfrm>
            <a:off x="772255" y="8614747"/>
            <a:ext cx="293308" cy="26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37" dirty="0">
                <a:solidFill>
                  <a:schemeClr val="bg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1</a:t>
            </a:r>
            <a:endParaRPr lang="en-GB" sz="1137" dirty="0">
              <a:solidFill>
                <a:schemeClr val="bg1"/>
              </a:solidFill>
              <a:latin typeface="Microsoft Sans Serif" panose="020B0604020202020204" pitchFamily="34" charset="0"/>
              <a:ea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3736012" y="7534451"/>
            <a:ext cx="2645055" cy="1977617"/>
            <a:chOff x="3736012" y="7534451"/>
            <a:chExt cx="2645055" cy="1977617"/>
          </a:xfrm>
        </p:grpSpPr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8CB39D8D-E942-ED7E-18F8-14EF3AAF0237}"/>
                </a:ext>
              </a:extLst>
            </p:cNvPr>
            <p:cNvGrpSpPr/>
            <p:nvPr/>
          </p:nvGrpSpPr>
          <p:grpSpPr>
            <a:xfrm>
              <a:off x="3778835" y="7534451"/>
              <a:ext cx="2584803" cy="1527940"/>
              <a:chOff x="1771649" y="1162055"/>
              <a:chExt cx="5265710" cy="3743321"/>
            </a:xfrm>
          </p:grpSpPr>
          <p:pic>
            <p:nvPicPr>
              <p:cNvPr id="84" name="Picture 83">
                <a:extLst>
                  <a:ext uri="{FF2B5EF4-FFF2-40B4-BE49-F238E27FC236}">
                    <a16:creationId xmlns:a16="http://schemas.microsoft.com/office/drawing/2014/main" id="{CF70D3D9-AF12-1531-033B-5231895205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 rot="5400000">
                <a:off x="2124013" y="809691"/>
                <a:ext cx="1895473" cy="2600201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85" name="Picture 84">
                <a:extLst>
                  <a:ext uri="{FF2B5EF4-FFF2-40B4-BE49-F238E27FC236}">
                    <a16:creationId xmlns:a16="http://schemas.microsoft.com/office/drawing/2014/main" id="{BCEB9824-4599-CBEE-F690-B5705F2C66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71850" y="1162055"/>
                <a:ext cx="2665509" cy="1895473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86" name="Picture 85">
                <a:extLst>
                  <a:ext uri="{FF2B5EF4-FFF2-40B4-BE49-F238E27FC236}">
                    <a16:creationId xmlns:a16="http://schemas.microsoft.com/office/drawing/2014/main" id="{D7A5F9EB-B641-7A01-734F-871F5D864E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71649" y="3057528"/>
                <a:ext cx="2598534" cy="184784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93B22616-01C8-01FD-5F76-7F463C7356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70185" y="3057528"/>
                <a:ext cx="2667174" cy="184784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73AB230A-C479-C125-1C4B-8D52F29DF05D}"/>
                  </a:ext>
                </a:extLst>
              </p:cNvPr>
              <p:cNvSpPr txBox="1"/>
              <p:nvPr/>
            </p:nvSpPr>
            <p:spPr>
              <a:xfrm>
                <a:off x="3923967" y="2494229"/>
                <a:ext cx="398324" cy="4934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>
                    <a:solidFill>
                      <a:schemeClr val="bg1"/>
                    </a:solidFill>
                    <a:latin typeface="Microsoft Sans Serif" panose="020B0604020202020204" pitchFamily="34" charset="0"/>
                    <a:cs typeface="Microsoft Sans Serif" panose="020B0604020202020204" pitchFamily="34" charset="0"/>
                  </a:rPr>
                  <a:t>3</a:t>
                </a:r>
                <a:endParaRPr lang="en-GB" sz="11400" dirty="0">
                  <a:solidFill>
                    <a:schemeClr val="bg1"/>
                  </a:solidFill>
                  <a:latin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1F7EF896-70AA-A3BC-CCD2-4AB2F488F424}"/>
                  </a:ext>
                </a:extLst>
              </p:cNvPr>
              <p:cNvSpPr txBox="1"/>
              <p:nvPr/>
            </p:nvSpPr>
            <p:spPr>
              <a:xfrm>
                <a:off x="6623267" y="2510401"/>
                <a:ext cx="398324" cy="4934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>
                    <a:solidFill>
                      <a:schemeClr val="bg1"/>
                    </a:solidFill>
                    <a:latin typeface="Microsoft Sans Serif" panose="020B0604020202020204" pitchFamily="34" charset="0"/>
                    <a:cs typeface="Microsoft Sans Serif" panose="020B0604020202020204" pitchFamily="34" charset="0"/>
                  </a:rPr>
                  <a:t>2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C5402AB0-EE2E-0FDC-09DE-6B7B24A60442}"/>
                  </a:ext>
                </a:extLst>
              </p:cNvPr>
              <p:cNvSpPr txBox="1"/>
              <p:nvPr/>
            </p:nvSpPr>
            <p:spPr>
              <a:xfrm>
                <a:off x="3337128" y="4342075"/>
                <a:ext cx="1128395" cy="4934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100" dirty="0">
                    <a:solidFill>
                      <a:schemeClr val="bg1"/>
                    </a:solidFill>
                    <a:latin typeface="Microsoft Sans Serif" panose="020B0604020202020204" pitchFamily="34" charset="0"/>
                    <a:cs typeface="Microsoft Sans Serif" panose="020B0604020202020204" pitchFamily="34" charset="0"/>
                  </a:rPr>
                  <a:t>1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7FF31918-3EB1-5375-13F3-C0FFEFAE7992}"/>
                  </a:ext>
                </a:extLst>
              </p:cNvPr>
              <p:cNvSpPr txBox="1"/>
              <p:nvPr/>
            </p:nvSpPr>
            <p:spPr>
              <a:xfrm>
                <a:off x="6623263" y="4342073"/>
                <a:ext cx="398324" cy="4934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>
                    <a:solidFill>
                      <a:schemeClr val="bg1"/>
                    </a:solidFill>
                    <a:latin typeface="Microsoft Sans Serif" panose="020B0604020202020204" pitchFamily="34" charset="0"/>
                    <a:cs typeface="Microsoft Sans Serif" panose="020B0604020202020204" pitchFamily="34" charset="0"/>
                  </a:rPr>
                  <a:t>0</a:t>
                </a:r>
                <a:endParaRPr lang="en-GB" sz="1200" dirty="0">
                  <a:solidFill>
                    <a:schemeClr val="bg1"/>
                  </a:solidFill>
                  <a:latin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</p:grp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CCAC71B2-FD2A-514A-EF36-2872E79B1510}"/>
                </a:ext>
              </a:extLst>
            </p:cNvPr>
            <p:cNvSpPr txBox="1"/>
            <p:nvPr/>
          </p:nvSpPr>
          <p:spPr>
            <a:xfrm>
              <a:off x="3736012" y="9042709"/>
              <a:ext cx="2645055" cy="469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eaf</a:t>
              </a:r>
              <a:r>
                <a:rPr lang="de-DE" sz="1400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</a:t>
              </a:r>
              <a:r>
                <a:rPr lang="de-DE" sz="1400" b="1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Hairiness</a:t>
              </a:r>
              <a:endParaRPr lang="de-DE" sz="1400" b="1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  <a:p>
              <a:pPr algn="ctr"/>
              <a:r>
                <a:rPr lang="de-DE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3. Very </a:t>
              </a:r>
              <a:r>
                <a:rPr lang="de-DE" sz="100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hairy</a:t>
              </a:r>
              <a:r>
                <a:rPr lang="de-DE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; 1/2. </a:t>
              </a:r>
              <a:r>
                <a:rPr lang="de-DE" sz="100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Hairy</a:t>
              </a:r>
              <a:r>
                <a:rPr lang="de-DE" sz="1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; 0. </a:t>
              </a:r>
              <a:r>
                <a:rPr lang="de-DE" sz="1000" dirty="0" err="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Glabrous</a:t>
              </a:r>
              <a:endParaRPr lang="en-GB" sz="10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467674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6184" b="16524"/>
          <a:stretch/>
        </p:blipFill>
        <p:spPr>
          <a:xfrm>
            <a:off x="3467649" y="1170190"/>
            <a:ext cx="3468887" cy="185209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8054" b="15541"/>
          <a:stretch/>
        </p:blipFill>
        <p:spPr>
          <a:xfrm>
            <a:off x="-51767" y="3628833"/>
            <a:ext cx="3480767" cy="180723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5626" b="14995"/>
          <a:stretch/>
        </p:blipFill>
        <p:spPr>
          <a:xfrm>
            <a:off x="3467144" y="3506601"/>
            <a:ext cx="3469392" cy="192946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6916" b="14770"/>
          <a:stretch/>
        </p:blipFill>
        <p:spPr>
          <a:xfrm>
            <a:off x="9067" y="6023759"/>
            <a:ext cx="3493678" cy="192341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6276" b="14985"/>
          <a:stretch/>
        </p:blipFill>
        <p:spPr>
          <a:xfrm>
            <a:off x="3467144" y="5952459"/>
            <a:ext cx="3469392" cy="199471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4601" b="23014"/>
          <a:stretch/>
        </p:blipFill>
        <p:spPr>
          <a:xfrm>
            <a:off x="-51767" y="1170189"/>
            <a:ext cx="3480767" cy="1807238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2a</a:t>
            </a:r>
          </a:p>
        </p:txBody>
      </p:sp>
    </p:spTree>
    <p:extLst>
      <p:ext uri="{BB962C8B-B14F-4D97-AF65-F5344CB8AC3E}">
        <p14:creationId xmlns:p14="http://schemas.microsoft.com/office/powerpoint/2010/main" val="13882775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/>
          <p:cNvGrpSpPr/>
          <p:nvPr/>
        </p:nvGrpSpPr>
        <p:grpSpPr>
          <a:xfrm>
            <a:off x="3459110" y="5789802"/>
            <a:ext cx="3462526" cy="2859572"/>
            <a:chOff x="3529043" y="5977428"/>
            <a:chExt cx="3265241" cy="2872740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151" t="15994" b="22666"/>
            <a:stretch/>
          </p:blipFill>
          <p:spPr>
            <a:xfrm>
              <a:off x="3703320" y="6457091"/>
              <a:ext cx="3090964" cy="182491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93773"/>
            <a:stretch/>
          </p:blipFill>
          <p:spPr>
            <a:xfrm>
              <a:off x="3529043" y="5977428"/>
              <a:ext cx="209550" cy="2872740"/>
            </a:xfrm>
            <a:prstGeom prst="rect">
              <a:avLst/>
            </a:prstGeom>
          </p:spPr>
        </p:pic>
      </p:grpSp>
      <p:grpSp>
        <p:nvGrpSpPr>
          <p:cNvPr id="37" name="Group 36"/>
          <p:cNvGrpSpPr/>
          <p:nvPr/>
        </p:nvGrpSpPr>
        <p:grpSpPr>
          <a:xfrm>
            <a:off x="3433820" y="3132219"/>
            <a:ext cx="3492092" cy="2859572"/>
            <a:chOff x="3522876" y="2968538"/>
            <a:chExt cx="3293123" cy="2872740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208" t="14923" b="22287"/>
            <a:stretch/>
          </p:blipFill>
          <p:spPr>
            <a:xfrm>
              <a:off x="3689032" y="3412494"/>
              <a:ext cx="3126967" cy="1868093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93773"/>
            <a:stretch/>
          </p:blipFill>
          <p:spPr>
            <a:xfrm>
              <a:off x="3522876" y="2968538"/>
              <a:ext cx="209550" cy="2872740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3463542" y="764440"/>
            <a:ext cx="3471895" cy="2859572"/>
            <a:chOff x="3511668" y="764440"/>
            <a:chExt cx="3471895" cy="2859572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531" t="15729" b="21606"/>
            <a:stretch/>
          </p:blipFill>
          <p:spPr>
            <a:xfrm>
              <a:off x="3719385" y="1225519"/>
              <a:ext cx="3264178" cy="1791973"/>
            </a:xfrm>
            <a:prstGeom prst="rect">
              <a:avLst/>
            </a:prstGeom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93773"/>
            <a:stretch/>
          </p:blipFill>
          <p:spPr>
            <a:xfrm>
              <a:off x="3511668" y="764440"/>
              <a:ext cx="222211" cy="2859572"/>
            </a:xfrm>
            <a:prstGeom prst="rect">
              <a:avLst/>
            </a:prstGeom>
          </p:spPr>
        </p:pic>
      </p:grpSp>
      <p:grpSp>
        <p:nvGrpSpPr>
          <p:cNvPr id="33" name="Group 32"/>
          <p:cNvGrpSpPr/>
          <p:nvPr/>
        </p:nvGrpSpPr>
        <p:grpSpPr>
          <a:xfrm>
            <a:off x="26016" y="764440"/>
            <a:ext cx="3424990" cy="2859573"/>
            <a:chOff x="245392" y="211743"/>
            <a:chExt cx="3229844" cy="2872740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7339" t="15490" b="22198"/>
            <a:stretch/>
          </p:blipFill>
          <p:spPr>
            <a:xfrm>
              <a:off x="373896" y="660321"/>
              <a:ext cx="3101340" cy="1804445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93773"/>
            <a:stretch/>
          </p:blipFill>
          <p:spPr>
            <a:xfrm>
              <a:off x="245392" y="211743"/>
              <a:ext cx="209550" cy="2872740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4E01A77-1522-8FB5-311F-73DF111E9CAB}"/>
              </a:ext>
            </a:extLst>
          </p:cNvPr>
          <p:cNvGrpSpPr/>
          <p:nvPr/>
        </p:nvGrpSpPr>
        <p:grpSpPr>
          <a:xfrm>
            <a:off x="6568" y="3132219"/>
            <a:ext cx="3482892" cy="2859572"/>
            <a:chOff x="54694" y="3549311"/>
            <a:chExt cx="3482892" cy="2859572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774" t="16058" b="21916"/>
            <a:stretch/>
          </p:blipFill>
          <p:spPr>
            <a:xfrm>
              <a:off x="282087" y="4028303"/>
              <a:ext cx="3255499" cy="1836865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93773"/>
            <a:stretch/>
          </p:blipFill>
          <p:spPr>
            <a:xfrm>
              <a:off x="54694" y="3549311"/>
              <a:ext cx="222211" cy="2859572"/>
            </a:xfrm>
            <a:prstGeom prst="rect">
              <a:avLst/>
            </a:prstGeom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3AF84129-E350-D8BF-F7A5-E21305E03CA2}"/>
              </a:ext>
            </a:extLst>
          </p:cNvPr>
          <p:cNvGrpSpPr/>
          <p:nvPr/>
        </p:nvGrpSpPr>
        <p:grpSpPr>
          <a:xfrm>
            <a:off x="26016" y="5789802"/>
            <a:ext cx="3487606" cy="2859572"/>
            <a:chOff x="74142" y="6640028"/>
            <a:chExt cx="3487606" cy="2859572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7751" t="16123" b="22410"/>
            <a:stretch/>
          </p:blipFill>
          <p:spPr>
            <a:xfrm>
              <a:off x="332156" y="7117492"/>
              <a:ext cx="3229592" cy="182034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93773"/>
            <a:stretch/>
          </p:blipFill>
          <p:spPr>
            <a:xfrm>
              <a:off x="74142" y="6640028"/>
              <a:ext cx="222211" cy="2859572"/>
            </a:xfrm>
            <a:prstGeom prst="rect">
              <a:avLst/>
            </a:prstGeom>
          </p:spPr>
        </p:pic>
      </p:grpSp>
      <p:sp>
        <p:nvSpPr>
          <p:cNvPr id="50" name="TextBox 49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2b</a:t>
            </a:r>
          </a:p>
        </p:txBody>
      </p:sp>
    </p:spTree>
    <p:extLst>
      <p:ext uri="{BB962C8B-B14F-4D97-AF65-F5344CB8AC3E}">
        <p14:creationId xmlns:p14="http://schemas.microsoft.com/office/powerpoint/2010/main" val="42177558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625289" y="6735244"/>
            <a:ext cx="5588711" cy="3179134"/>
            <a:chOff x="-32023" y="12087477"/>
            <a:chExt cx="9935189" cy="5651623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3406" y="12451332"/>
              <a:ext cx="9509760" cy="480060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3111069" y="17259552"/>
              <a:ext cx="4191001" cy="4795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Chromosome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-1887749" y="14619479"/>
              <a:ext cx="4191000" cy="4795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-log</a:t>
              </a:r>
              <a:r>
                <a:rPr lang="en-GB" sz="1153" baseline="-25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0</a:t>
              </a:r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(</a:t>
              </a:r>
              <a:r>
                <a:rPr lang="en-GB" sz="1153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P</a:t>
              </a:r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794364" y="12087477"/>
              <a:ext cx="4824412" cy="4795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53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Cambium color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3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1C1D0140-7F0B-46F0-AC31-948E4EE43C80}"/>
              </a:ext>
            </a:extLst>
          </p:cNvPr>
          <p:cNvGrpSpPr/>
          <p:nvPr/>
        </p:nvGrpSpPr>
        <p:grpSpPr>
          <a:xfrm>
            <a:off x="625290" y="3478942"/>
            <a:ext cx="5588710" cy="3179134"/>
            <a:chOff x="625290" y="3543110"/>
            <a:chExt cx="5588710" cy="3179134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60699" y="3741355"/>
              <a:ext cx="5353301" cy="2711135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2393331" y="6452490"/>
              <a:ext cx="2357508" cy="269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Chromosome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-418588" y="4967404"/>
              <a:ext cx="2357509" cy="269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-log</a:t>
              </a:r>
              <a:r>
                <a:rPr lang="en-GB" sz="1153" baseline="-25000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10</a:t>
              </a:r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(</a:t>
              </a:r>
              <a:r>
                <a:rPr lang="en-GB" sz="1153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P</a:t>
              </a:r>
              <a:r>
                <a:rPr lang="en-GB" sz="1153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15179" y="3543110"/>
              <a:ext cx="2713814" cy="2697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53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External root color</a:t>
              </a:r>
            </a:p>
          </p:txBody>
        </p:sp>
        <p:sp>
          <p:nvSpPr>
            <p:cNvPr id="34" name="Left Arrow 33"/>
            <p:cNvSpPr/>
            <p:nvPr/>
          </p:nvSpPr>
          <p:spPr>
            <a:xfrm>
              <a:off x="2247770" y="3955517"/>
              <a:ext cx="264681" cy="141274"/>
            </a:xfrm>
            <a:prstGeom prst="lef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3467">
                <a:solidFill>
                  <a:schemeClr val="accent4">
                    <a:lumMod val="75000"/>
                  </a:schemeClr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393331" y="3853858"/>
              <a:ext cx="978128" cy="336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89" b="1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Y</a:t>
              </a:r>
              <a:r>
                <a:rPr lang="en-GB" sz="1589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locus</a:t>
              </a:r>
            </a:p>
          </p:txBody>
        </p:sp>
        <p:sp>
          <p:nvSpPr>
            <p:cNvPr id="40" name="Left Arrow 39"/>
            <p:cNvSpPr/>
            <p:nvPr/>
          </p:nvSpPr>
          <p:spPr>
            <a:xfrm rot="10800000">
              <a:off x="1881863" y="4326319"/>
              <a:ext cx="264681" cy="141274"/>
            </a:xfrm>
            <a:prstGeom prst="lef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3467" dirty="0">
                <a:solidFill>
                  <a:schemeClr val="tx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016878" y="4210610"/>
              <a:ext cx="897880" cy="336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89" b="1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R</a:t>
              </a:r>
              <a:r>
                <a:rPr lang="en-GB" sz="1589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locus</a:t>
              </a:r>
            </a:p>
          </p:txBody>
        </p:sp>
      </p:grpSp>
      <p:sp>
        <p:nvSpPr>
          <p:cNvPr id="18" name="Sprechblase: rechteckig mit abgerundeten Ecken 17">
            <a:extLst>
              <a:ext uri="{FF2B5EF4-FFF2-40B4-BE49-F238E27FC236}">
                <a16:creationId xmlns:a16="http://schemas.microsoft.com/office/drawing/2014/main" id="{C2347FB3-00A3-D0FC-98F1-1379DDDAEF17}"/>
              </a:ext>
            </a:extLst>
          </p:cNvPr>
          <p:cNvSpPr/>
          <p:nvPr/>
        </p:nvSpPr>
        <p:spPr>
          <a:xfrm>
            <a:off x="4211392" y="740535"/>
            <a:ext cx="1010991" cy="727657"/>
          </a:xfrm>
          <a:prstGeom prst="wedgeRoundRectCallout">
            <a:avLst>
              <a:gd name="adj1" fmla="val -176247"/>
              <a:gd name="adj2" fmla="val -21571"/>
              <a:gd name="adj3" fmla="val 16667"/>
            </a:avLst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black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4D31BD5A-6AC3-57D9-AE5D-E4197BE901B4}"/>
              </a:ext>
            </a:extLst>
          </p:cNvPr>
          <p:cNvGrpSpPr/>
          <p:nvPr/>
        </p:nvGrpSpPr>
        <p:grpSpPr>
          <a:xfrm>
            <a:off x="625288" y="121892"/>
            <a:ext cx="5592092" cy="3179134"/>
            <a:chOff x="625288" y="186060"/>
            <a:chExt cx="5592092" cy="3179134"/>
          </a:xfrm>
        </p:grpSpPr>
        <p:grpSp>
          <p:nvGrpSpPr>
            <p:cNvPr id="2" name="Group 1"/>
            <p:cNvGrpSpPr/>
            <p:nvPr/>
          </p:nvGrpSpPr>
          <p:grpSpPr>
            <a:xfrm>
              <a:off x="625288" y="186060"/>
              <a:ext cx="5592092" cy="3179134"/>
              <a:chOff x="-32023" y="-65271"/>
              <a:chExt cx="9941198" cy="5651623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71474" y="306204"/>
                <a:ext cx="9537701" cy="4800600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3111070" y="5106804"/>
                <a:ext cx="4190999" cy="4795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Chromosome</a:t>
                </a: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 rot="16200000">
                <a:off x="-1887749" y="2466731"/>
                <a:ext cx="4191000" cy="4795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-log</a:t>
                </a:r>
                <a:r>
                  <a:rPr lang="en-GB" sz="1153" baseline="-2500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10</a:t>
                </a:r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(</a:t>
                </a:r>
                <a:r>
                  <a:rPr lang="en-GB" sz="1153" i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P</a:t>
                </a:r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)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794365" y="-65271"/>
                <a:ext cx="4824413" cy="4795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Flesh color</a:t>
                </a:r>
              </a:p>
            </p:txBody>
          </p:sp>
        </p:grpSp>
        <p:sp>
          <p:nvSpPr>
            <p:cNvPr id="37" name="Left Arrow 36"/>
            <p:cNvSpPr/>
            <p:nvPr/>
          </p:nvSpPr>
          <p:spPr>
            <a:xfrm rot="10800000">
              <a:off x="1870951" y="1373318"/>
              <a:ext cx="264681" cy="141274"/>
            </a:xfrm>
            <a:prstGeom prst="lef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3467">
                <a:solidFill>
                  <a:srgbClr val="FF0000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016877" y="1257609"/>
              <a:ext cx="910617" cy="336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89" b="1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R</a:t>
              </a:r>
              <a:r>
                <a:rPr lang="en-GB" sz="1589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locus</a:t>
              </a: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2257294" y="834204"/>
              <a:ext cx="1068507" cy="336887"/>
              <a:chOff x="2807975" y="1348314"/>
              <a:chExt cx="1899512" cy="598894"/>
            </a:xfrm>
          </p:grpSpPr>
          <p:sp>
            <p:nvSpPr>
              <p:cNvPr id="31" name="Left Arrow 30"/>
              <p:cNvSpPr/>
              <p:nvPr/>
            </p:nvSpPr>
            <p:spPr>
              <a:xfrm>
                <a:off x="2807975" y="1529034"/>
                <a:ext cx="470530" cy="251146"/>
              </a:xfrm>
              <a:prstGeom prst="left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3467" dirty="0">
                  <a:solidFill>
                    <a:schemeClr val="tx1"/>
                  </a:solidFill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163474" y="1348314"/>
                <a:ext cx="1544013" cy="5988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589" b="1" i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Y</a:t>
                </a:r>
                <a:r>
                  <a:rPr lang="en-GB" sz="1589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 locu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594247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4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AED7039-4DD6-77BC-796E-DC892BC513AC}"/>
              </a:ext>
            </a:extLst>
          </p:cNvPr>
          <p:cNvGrpSpPr/>
          <p:nvPr/>
        </p:nvGrpSpPr>
        <p:grpSpPr>
          <a:xfrm>
            <a:off x="-26286" y="296760"/>
            <a:ext cx="6728433" cy="4169371"/>
            <a:chOff x="635166" y="590095"/>
            <a:chExt cx="5445713" cy="3204153"/>
          </a:xfrm>
        </p:grpSpPr>
        <p:grpSp>
          <p:nvGrpSpPr>
            <p:cNvPr id="22" name="Group 21"/>
            <p:cNvGrpSpPr/>
            <p:nvPr/>
          </p:nvGrpSpPr>
          <p:grpSpPr>
            <a:xfrm>
              <a:off x="635166" y="590095"/>
              <a:ext cx="5445713" cy="3204153"/>
              <a:chOff x="-14461" y="11762430"/>
              <a:chExt cx="9680975" cy="5696100"/>
            </a:xfrm>
          </p:grpSpPr>
          <p:pic>
            <p:nvPicPr>
              <p:cNvPr id="23" name="Picture 22"/>
              <p:cNvPicPr>
                <a:picLocks noChangeAspect="1"/>
              </p:cNvPicPr>
              <p:nvPr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27661" y="12192000"/>
                <a:ext cx="9338853" cy="4815841"/>
              </a:xfrm>
              <a:prstGeom prst="rect">
                <a:avLst/>
              </a:prstGeom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3059111" y="16978982"/>
                <a:ext cx="4190999" cy="4795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Chromosome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>
                <a:off x="-1915899" y="14383030"/>
                <a:ext cx="4191002" cy="3881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-log</a:t>
                </a:r>
                <a:r>
                  <a:rPr lang="en-GB" sz="1153" baseline="-2500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10</a:t>
                </a:r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(</a:t>
                </a:r>
                <a:r>
                  <a:rPr lang="en-GB" sz="1153" i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P</a:t>
                </a:r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)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742405" y="11762430"/>
                <a:ext cx="4824413" cy="4795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Leaf color</a:t>
                </a:r>
              </a:p>
            </p:txBody>
          </p:sp>
        </p:grpSp>
        <p:sp>
          <p:nvSpPr>
            <p:cNvPr id="14" name="Left Arrow 13"/>
            <p:cNvSpPr/>
            <p:nvPr/>
          </p:nvSpPr>
          <p:spPr>
            <a:xfrm rot="10800000">
              <a:off x="1861141" y="1483336"/>
              <a:ext cx="264681" cy="141274"/>
            </a:xfrm>
            <a:prstGeom prst="lef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3467">
                <a:solidFill>
                  <a:schemeClr val="tx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058844" y="1412005"/>
              <a:ext cx="858561" cy="2588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89" b="1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R</a:t>
              </a:r>
              <a:r>
                <a:rPr lang="en-GB" sz="1589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locus</a:t>
              </a:r>
            </a:p>
          </p:txBody>
        </p:sp>
        <p:sp>
          <p:nvSpPr>
            <p:cNvPr id="17" name="Left Arrow 16"/>
            <p:cNvSpPr/>
            <p:nvPr/>
          </p:nvSpPr>
          <p:spPr>
            <a:xfrm>
              <a:off x="2205000" y="1982409"/>
              <a:ext cx="264681" cy="141274"/>
            </a:xfrm>
            <a:prstGeom prst="lef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3467">
                <a:solidFill>
                  <a:schemeClr val="tx1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261240" y="1923773"/>
              <a:ext cx="1102480" cy="2588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89" b="1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Y </a:t>
              </a:r>
              <a:r>
                <a:rPr lang="en-GB" sz="1589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locus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B7850F7-B810-253D-C720-2E6FE25A7C52}"/>
              </a:ext>
            </a:extLst>
          </p:cNvPr>
          <p:cNvGrpSpPr/>
          <p:nvPr/>
        </p:nvGrpSpPr>
        <p:grpSpPr>
          <a:xfrm>
            <a:off x="-20480" y="4662644"/>
            <a:ext cx="6884287" cy="4169371"/>
            <a:chOff x="635165" y="4043603"/>
            <a:chExt cx="5571855" cy="3204153"/>
          </a:xfrm>
        </p:grpSpPr>
        <p:grpSp>
          <p:nvGrpSpPr>
            <p:cNvPr id="27" name="Group 26"/>
            <p:cNvGrpSpPr/>
            <p:nvPr/>
          </p:nvGrpSpPr>
          <p:grpSpPr>
            <a:xfrm>
              <a:off x="635165" y="4043603"/>
              <a:ext cx="5571855" cy="3204153"/>
              <a:chOff x="-14462" y="6397599"/>
              <a:chExt cx="9905222" cy="5696100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 rotWithShape="1"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14960" y="6800851"/>
                <a:ext cx="9575800" cy="4813300"/>
              </a:xfrm>
              <a:prstGeom prst="rect">
                <a:avLst/>
              </a:prstGeom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3059111" y="11614151"/>
                <a:ext cx="4191000" cy="4795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Chromosome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6200000">
                <a:off x="-1915900" y="9018198"/>
                <a:ext cx="4191002" cy="3881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-log</a:t>
                </a:r>
                <a:r>
                  <a:rPr lang="en-GB" sz="1153" baseline="-25000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10</a:t>
                </a:r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(</a:t>
                </a:r>
                <a:r>
                  <a:rPr lang="en-GB" sz="1153" i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P</a:t>
                </a:r>
                <a:r>
                  <a:rPr lang="en-GB" sz="1153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)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742402" y="6397599"/>
                <a:ext cx="4824415" cy="4795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53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Petiole color</a:t>
                </a:r>
              </a:p>
            </p:txBody>
          </p:sp>
        </p:grpSp>
        <p:sp>
          <p:nvSpPr>
            <p:cNvPr id="33" name="Left Arrow 32"/>
            <p:cNvSpPr/>
            <p:nvPr/>
          </p:nvSpPr>
          <p:spPr>
            <a:xfrm>
              <a:off x="2197261" y="5181598"/>
              <a:ext cx="264681" cy="141274"/>
            </a:xfrm>
            <a:prstGeom prst="lef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3467">
                <a:solidFill>
                  <a:schemeClr val="accent4">
                    <a:lumMod val="75000"/>
                  </a:schemeClr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461943" y="5126184"/>
              <a:ext cx="707556" cy="2588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89" b="1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Y</a:t>
              </a:r>
              <a:r>
                <a:rPr lang="en-GB" sz="1589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locus</a:t>
              </a:r>
            </a:p>
          </p:txBody>
        </p:sp>
        <p:sp>
          <p:nvSpPr>
            <p:cNvPr id="36" name="Left Arrow 35"/>
            <p:cNvSpPr/>
            <p:nvPr/>
          </p:nvSpPr>
          <p:spPr>
            <a:xfrm rot="10800000">
              <a:off x="1868931" y="4567442"/>
              <a:ext cx="264681" cy="141274"/>
            </a:xfrm>
            <a:prstGeom prst="lef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3467">
                <a:solidFill>
                  <a:srgbClr val="FF0000"/>
                </a:solidFill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054144" y="4500004"/>
              <a:ext cx="802296" cy="2588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89" b="1" i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R</a:t>
              </a:r>
              <a:r>
                <a:rPr lang="en-GB" sz="1589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 locu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195673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5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-2338" y="199785"/>
            <a:ext cx="6791764" cy="4661774"/>
            <a:chOff x="-2338" y="199785"/>
            <a:chExt cx="6791764" cy="4661774"/>
          </a:xfrm>
        </p:grpSpPr>
        <p:grpSp>
          <p:nvGrpSpPr>
            <p:cNvPr id="10" name="Group 9"/>
            <p:cNvGrpSpPr/>
            <p:nvPr/>
          </p:nvGrpSpPr>
          <p:grpSpPr>
            <a:xfrm>
              <a:off x="72123" y="297180"/>
              <a:ext cx="6717303" cy="4564379"/>
              <a:chOff x="698512" y="1346471"/>
              <a:chExt cx="5462833" cy="3253675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698512" y="1346471"/>
                <a:ext cx="5462833" cy="3253675"/>
                <a:chOff x="67959" y="132615"/>
                <a:chExt cx="6724364" cy="4005045"/>
              </a:xfrm>
            </p:grpSpPr>
            <p:grpSp>
              <p:nvGrpSpPr>
                <p:cNvPr id="22" name="Group 21"/>
                <p:cNvGrpSpPr/>
                <p:nvPr/>
              </p:nvGrpSpPr>
              <p:grpSpPr>
                <a:xfrm>
                  <a:off x="67959" y="132615"/>
                  <a:ext cx="6724364" cy="4005045"/>
                  <a:chOff x="-111077" y="310550"/>
                  <a:chExt cx="12216812" cy="6236899"/>
                </a:xfrm>
              </p:grpSpPr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 rotWithShape="1">
                  <a:blip r:embed="rId2" cstate="screen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1065429" y="310550"/>
                    <a:ext cx="11040306" cy="6236899"/>
                  </a:xfrm>
                  <a:prstGeom prst="rect">
                    <a:avLst/>
                  </a:prstGeom>
                </p:spPr>
              </p:pic>
              <p:sp>
                <p:nvSpPr>
                  <p:cNvPr id="5" name="TextBox 4"/>
                  <p:cNvSpPr txBox="1"/>
                  <p:nvPr/>
                </p:nvSpPr>
                <p:spPr>
                  <a:xfrm rot="16200000">
                    <a:off x="-648167" y="2429021"/>
                    <a:ext cx="1492367" cy="4181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94" b="1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rPr>
                      <a:t>Monogerm</a:t>
                    </a:r>
                  </a:p>
                </p:txBody>
              </p:sp>
              <p:sp>
                <p:nvSpPr>
                  <p:cNvPr id="9" name="TextBox 8"/>
                  <p:cNvSpPr txBox="1"/>
                  <p:nvPr/>
                </p:nvSpPr>
                <p:spPr>
                  <a:xfrm rot="16200000">
                    <a:off x="-593350" y="4163690"/>
                    <a:ext cx="1382732" cy="4181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94" b="1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rPr>
                      <a:t>Multigerm</a:t>
                    </a:r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 rot="16200000">
                    <a:off x="-445800" y="5497263"/>
                    <a:ext cx="1087640" cy="4181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94" b="1" dirty="0">
                        <a:latin typeface="Microsoft Sans Serif" panose="020B0604020202020204" pitchFamily="34" charset="0"/>
                        <a:ea typeface="Microsoft Sans Serif" panose="020B0604020202020204" pitchFamily="34" charset="0"/>
                        <a:cs typeface="Microsoft Sans Serif" panose="020B0604020202020204" pitchFamily="34" charset="0"/>
                      </a:rPr>
                      <a:t>Hybrid</a:t>
                    </a:r>
                  </a:p>
                </p:txBody>
              </p:sp>
            </p:grpSp>
            <p:sp>
              <p:nvSpPr>
                <p:cNvPr id="23" name="Rounded Rectangle 22"/>
                <p:cNvSpPr/>
                <p:nvPr/>
              </p:nvSpPr>
              <p:spPr>
                <a:xfrm>
                  <a:off x="4251961" y="1004509"/>
                  <a:ext cx="194310" cy="3030281"/>
                </a:xfrm>
                <a:prstGeom prst="roundRect">
                  <a:avLst/>
                </a:prstGeom>
                <a:noFill/>
                <a:ln w="38100">
                  <a:solidFill>
                    <a:srgbClr val="FF0000"/>
                  </a:solidFill>
                  <a:prstDash val="soli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951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endParaRPr>
                </a:p>
              </p:txBody>
            </p:sp>
          </p:grpSp>
          <p:sp>
            <p:nvSpPr>
              <p:cNvPr id="7" name="Geschweifte Klammer links 6">
                <a:extLst>
                  <a:ext uri="{FF2B5EF4-FFF2-40B4-BE49-F238E27FC236}">
                    <a16:creationId xmlns:a16="http://schemas.microsoft.com/office/drawing/2014/main" id="{13D3AF56-7727-CA6D-BB75-499BABD1C8E0}"/>
                  </a:ext>
                </a:extLst>
              </p:cNvPr>
              <p:cNvSpPr/>
              <p:nvPr/>
            </p:nvSpPr>
            <p:spPr>
              <a:xfrm>
                <a:off x="992957" y="2120691"/>
                <a:ext cx="195590" cy="880057"/>
              </a:xfrm>
              <a:prstGeom prst="leftBrac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Geschweifte Klammer links 6">
                <a:extLst>
                  <a:ext uri="{FF2B5EF4-FFF2-40B4-BE49-F238E27FC236}">
                    <a16:creationId xmlns:a16="http://schemas.microsoft.com/office/drawing/2014/main" id="{13D3AF56-7727-CA6D-BB75-499BABD1C8E0}"/>
                  </a:ext>
                </a:extLst>
              </p:cNvPr>
              <p:cNvSpPr/>
              <p:nvPr/>
            </p:nvSpPr>
            <p:spPr>
              <a:xfrm>
                <a:off x="992957" y="3098747"/>
                <a:ext cx="195590" cy="727590"/>
              </a:xfrm>
              <a:prstGeom prst="leftBrac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Geschweifte Klammer links 6">
                <a:extLst>
                  <a:ext uri="{FF2B5EF4-FFF2-40B4-BE49-F238E27FC236}">
                    <a16:creationId xmlns:a16="http://schemas.microsoft.com/office/drawing/2014/main" id="{13D3AF56-7727-CA6D-BB75-499BABD1C8E0}"/>
                  </a:ext>
                </a:extLst>
              </p:cNvPr>
              <p:cNvSpPr/>
              <p:nvPr/>
            </p:nvSpPr>
            <p:spPr>
              <a:xfrm>
                <a:off x="992957" y="3922179"/>
                <a:ext cx="195590" cy="478371"/>
              </a:xfrm>
              <a:prstGeom prst="leftBrac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-2338" y="199785"/>
              <a:ext cx="4169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-2338" y="5077404"/>
            <a:ext cx="6847639" cy="4485503"/>
            <a:chOff x="-2338" y="5077404"/>
            <a:chExt cx="6847639" cy="4485503"/>
          </a:xfrm>
        </p:grpSpPr>
        <p:grpSp>
          <p:nvGrpSpPr>
            <p:cNvPr id="6" name="Group 5"/>
            <p:cNvGrpSpPr/>
            <p:nvPr/>
          </p:nvGrpSpPr>
          <p:grpSpPr>
            <a:xfrm>
              <a:off x="348493" y="5077404"/>
              <a:ext cx="6496808" cy="4485503"/>
              <a:chOff x="218011" y="4464447"/>
              <a:chExt cx="6519943" cy="4502432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1421"/>
              <a:stretch/>
            </p:blipFill>
            <p:spPr>
              <a:xfrm>
                <a:off x="218011" y="4464447"/>
                <a:ext cx="6513570" cy="987323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1" r="590"/>
              <a:stretch/>
            </p:blipFill>
            <p:spPr>
              <a:xfrm>
                <a:off x="218011" y="5432587"/>
                <a:ext cx="6519943" cy="835428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5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2288"/>
              <a:stretch/>
            </p:blipFill>
            <p:spPr>
              <a:xfrm>
                <a:off x="243501" y="6419910"/>
                <a:ext cx="6488080" cy="2546969"/>
              </a:xfrm>
              <a:prstGeom prst="rect">
                <a:avLst/>
              </a:prstGeom>
            </p:spPr>
          </p:pic>
          <p:sp>
            <p:nvSpPr>
              <p:cNvPr id="16" name="Rounded Rectangle 15"/>
              <p:cNvSpPr/>
              <p:nvPr/>
            </p:nvSpPr>
            <p:spPr>
              <a:xfrm>
                <a:off x="2580955" y="8369300"/>
                <a:ext cx="102046" cy="597579"/>
              </a:xfrm>
              <a:prstGeom prst="roundRect">
                <a:avLst/>
              </a:prstGeom>
              <a:noFill/>
              <a:ln w="38100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951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endParaRPr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>
              <a:off x="0" y="5111063"/>
              <a:ext cx="4169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-2338" y="6075909"/>
              <a:ext cx="4169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461509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3301" y="797850"/>
            <a:ext cx="5569871" cy="403442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3301" y="5174504"/>
            <a:ext cx="5571400" cy="403442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35555279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54"/>
          <p:cNvGrpSpPr/>
          <p:nvPr/>
        </p:nvGrpSpPr>
        <p:grpSpPr>
          <a:xfrm>
            <a:off x="3508512" y="1256568"/>
            <a:ext cx="2737801" cy="2295402"/>
            <a:chOff x="112324" y="6102839"/>
            <a:chExt cx="3370040" cy="2825479"/>
          </a:xfrm>
        </p:grpSpPr>
        <p:sp>
          <p:nvSpPr>
            <p:cNvPr id="50" name="TextBox 49"/>
            <p:cNvSpPr txBox="1"/>
            <p:nvPr/>
          </p:nvSpPr>
          <p:spPr>
            <a:xfrm>
              <a:off x="112324" y="6102839"/>
              <a:ext cx="3370040" cy="29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75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Q-Q plot: External root color GWAS p-values</a:t>
              </a:r>
            </a:p>
          </p:txBody>
        </p:sp>
        <p:grpSp>
          <p:nvGrpSpPr>
            <p:cNvPr id="54" name="Group 53"/>
            <p:cNvGrpSpPr/>
            <p:nvPr/>
          </p:nvGrpSpPr>
          <p:grpSpPr>
            <a:xfrm>
              <a:off x="245100" y="6367452"/>
              <a:ext cx="2845019" cy="2560866"/>
              <a:chOff x="217495" y="6059860"/>
              <a:chExt cx="2845019" cy="2560866"/>
            </a:xfrm>
          </p:grpSpPr>
          <p:pic>
            <p:nvPicPr>
              <p:cNvPr id="49" name="Picture 48"/>
              <p:cNvPicPr>
                <a:picLocks noChangeAspect="1"/>
              </p:cNvPicPr>
              <p:nvPr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2303" y="6059860"/>
                <a:ext cx="2530211" cy="2256040"/>
              </a:xfrm>
              <a:prstGeom prst="rect">
                <a:avLst/>
              </a:prstGeom>
            </p:spPr>
          </p:pic>
          <p:pic>
            <p:nvPicPr>
              <p:cNvPr id="52" name="Picture 51"/>
              <p:cNvPicPr>
                <a:picLocks noChangeAspect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43421" y="8315900"/>
                <a:ext cx="2072820" cy="304826"/>
              </a:xfrm>
              <a:prstGeom prst="rect">
                <a:avLst/>
              </a:prstGeom>
            </p:spPr>
          </p:pic>
          <p:pic>
            <p:nvPicPr>
              <p:cNvPr id="53" name="Picture 52"/>
              <p:cNvPicPr>
                <a:picLocks noChangeAspect="1"/>
              </p:cNvPicPr>
              <p:nvPr/>
            </p:nvPicPr>
            <p:blipFill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7495" y="6151470"/>
                <a:ext cx="304826" cy="2072820"/>
              </a:xfrm>
              <a:prstGeom prst="rect">
                <a:avLst/>
              </a:prstGeom>
            </p:spPr>
          </p:pic>
        </p:grpSp>
      </p:grpSp>
      <p:grpSp>
        <p:nvGrpSpPr>
          <p:cNvPr id="63" name="Group 62"/>
          <p:cNvGrpSpPr/>
          <p:nvPr/>
        </p:nvGrpSpPr>
        <p:grpSpPr>
          <a:xfrm>
            <a:off x="620782" y="1263614"/>
            <a:ext cx="2627717" cy="2283593"/>
            <a:chOff x="230174" y="30625"/>
            <a:chExt cx="3234534" cy="2810942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2254" y="288367"/>
              <a:ext cx="2563589" cy="2242606"/>
            </a:xfrm>
            <a:prstGeom prst="rect">
              <a:avLst/>
            </a:prstGeom>
          </p:spPr>
        </p:pic>
        <p:sp>
          <p:nvSpPr>
            <p:cNvPr id="57" name="TextBox 56"/>
            <p:cNvSpPr txBox="1"/>
            <p:nvPr/>
          </p:nvSpPr>
          <p:spPr>
            <a:xfrm>
              <a:off x="230174" y="30625"/>
              <a:ext cx="3234534" cy="29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75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Q-Q plot: Monogermity GWAS p-values</a:t>
              </a:r>
            </a:p>
          </p:txBody>
        </p:sp>
        <p:pic>
          <p:nvPicPr>
            <p:cNvPr id="59" name="Picture 58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88306" y="2536741"/>
              <a:ext cx="2072820" cy="304826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3443" y="349573"/>
              <a:ext cx="304826" cy="2072820"/>
            </a:xfrm>
            <a:prstGeom prst="rect">
              <a:avLst/>
            </a:prstGeom>
          </p:spPr>
        </p:pic>
      </p:grpSp>
      <p:grpSp>
        <p:nvGrpSpPr>
          <p:cNvPr id="67" name="Group 66"/>
          <p:cNvGrpSpPr/>
          <p:nvPr/>
        </p:nvGrpSpPr>
        <p:grpSpPr>
          <a:xfrm>
            <a:off x="3452700" y="3669581"/>
            <a:ext cx="2954040" cy="2301199"/>
            <a:chOff x="17494" y="2985556"/>
            <a:chExt cx="3636215" cy="2832614"/>
          </a:xfrm>
        </p:grpSpPr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8269" y="3256362"/>
              <a:ext cx="2563589" cy="2229371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>
              <a:off x="17494" y="2985556"/>
              <a:ext cx="3636215" cy="29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75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Q-Q plot: Cambium ring color GWAS p-values</a:t>
              </a:r>
            </a:p>
          </p:txBody>
        </p:sp>
        <p:pic>
          <p:nvPicPr>
            <p:cNvPr id="65" name="Picture 64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6198" y="5513344"/>
              <a:ext cx="2072820" cy="304826"/>
            </a:xfrm>
            <a:prstGeom prst="rect">
              <a:avLst/>
            </a:prstGeom>
          </p:spPr>
        </p:pic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1335" y="3326176"/>
              <a:ext cx="304826" cy="2072820"/>
            </a:xfrm>
            <a:prstGeom prst="rect">
              <a:avLst/>
            </a:prstGeom>
          </p:spPr>
        </p:pic>
      </p:grpSp>
      <p:grpSp>
        <p:nvGrpSpPr>
          <p:cNvPr id="72" name="Group 71"/>
          <p:cNvGrpSpPr/>
          <p:nvPr/>
        </p:nvGrpSpPr>
        <p:grpSpPr>
          <a:xfrm>
            <a:off x="620782" y="3666392"/>
            <a:ext cx="2634895" cy="2292597"/>
            <a:chOff x="3593422" y="13774"/>
            <a:chExt cx="3243371" cy="2822025"/>
          </a:xfrm>
        </p:grpSpPr>
        <p:sp>
          <p:nvSpPr>
            <p:cNvPr id="68" name="TextBox 67"/>
            <p:cNvSpPr txBox="1"/>
            <p:nvPr/>
          </p:nvSpPr>
          <p:spPr>
            <a:xfrm>
              <a:off x="3646393" y="13774"/>
              <a:ext cx="3190400" cy="29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75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Q-Q plot: Root flesh color GWAS p-values</a:t>
              </a:r>
            </a:p>
          </p:txBody>
        </p:sp>
        <p:grpSp>
          <p:nvGrpSpPr>
            <p:cNvPr id="71" name="Group 70"/>
            <p:cNvGrpSpPr/>
            <p:nvPr/>
          </p:nvGrpSpPr>
          <p:grpSpPr>
            <a:xfrm>
              <a:off x="3593422" y="281684"/>
              <a:ext cx="2903963" cy="2554115"/>
              <a:chOff x="3593422" y="281684"/>
              <a:chExt cx="2903963" cy="2554115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 rotWithShape="1">
              <a:blip r:embed="rId7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98248" y="281684"/>
                <a:ext cx="2599137" cy="2248128"/>
              </a:xfrm>
              <a:prstGeom prst="rect">
                <a:avLst/>
              </a:prstGeom>
            </p:spPr>
          </p:pic>
          <p:pic>
            <p:nvPicPr>
              <p:cNvPr id="69" name="Picture 68"/>
              <p:cNvPicPr>
                <a:picLocks noChangeAspect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238285" y="2530973"/>
                <a:ext cx="2072820" cy="304826"/>
              </a:xfrm>
              <a:prstGeom prst="rect">
                <a:avLst/>
              </a:prstGeom>
            </p:spPr>
          </p:pic>
          <p:pic>
            <p:nvPicPr>
              <p:cNvPr id="70" name="Picture 69"/>
              <p:cNvPicPr>
                <a:picLocks noChangeAspect="1"/>
              </p:cNvPicPr>
              <p:nvPr/>
            </p:nvPicPr>
            <p:blipFill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93422" y="343805"/>
                <a:ext cx="304826" cy="2072820"/>
              </a:xfrm>
              <a:prstGeom prst="rect">
                <a:avLst/>
              </a:prstGeom>
            </p:spPr>
          </p:pic>
        </p:grpSp>
      </p:grpSp>
      <p:grpSp>
        <p:nvGrpSpPr>
          <p:cNvPr id="80" name="Group 79"/>
          <p:cNvGrpSpPr/>
          <p:nvPr/>
        </p:nvGrpSpPr>
        <p:grpSpPr>
          <a:xfrm>
            <a:off x="3629847" y="6196646"/>
            <a:ext cx="2631281" cy="2314077"/>
            <a:chOff x="3578355" y="6102839"/>
            <a:chExt cx="3238921" cy="2848466"/>
          </a:xfrm>
        </p:grpSpPr>
        <p:grpSp>
          <p:nvGrpSpPr>
            <p:cNvPr id="77" name="Group 76"/>
            <p:cNvGrpSpPr/>
            <p:nvPr/>
          </p:nvGrpSpPr>
          <p:grpSpPr>
            <a:xfrm>
              <a:off x="3578355" y="6102839"/>
              <a:ext cx="3238921" cy="2535054"/>
              <a:chOff x="3578355" y="6077439"/>
              <a:chExt cx="3238921" cy="2535054"/>
            </a:xfrm>
          </p:grpSpPr>
          <p:pic>
            <p:nvPicPr>
              <p:cNvPr id="73" name="Picture 72"/>
              <p:cNvPicPr>
                <a:picLocks noChangeAspect="1"/>
              </p:cNvPicPr>
              <p:nvPr/>
            </p:nvPicPr>
            <p:blipFill rotWithShape="1">
              <a:blip r:embed="rId8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98339" y="6367452"/>
                <a:ext cx="2537336" cy="2245041"/>
              </a:xfrm>
              <a:prstGeom prst="rect">
                <a:avLst/>
              </a:prstGeom>
            </p:spPr>
          </p:pic>
          <p:sp>
            <p:nvSpPr>
              <p:cNvPr id="76" name="TextBox 75"/>
              <p:cNvSpPr txBox="1"/>
              <p:nvPr/>
            </p:nvSpPr>
            <p:spPr>
              <a:xfrm>
                <a:off x="3578355" y="6077439"/>
                <a:ext cx="3238921" cy="29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75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Q-Q plot: Petiole color GWAS p-values</a:t>
                </a:r>
              </a:p>
            </p:txBody>
          </p:sp>
        </p:grpSp>
        <p:pic>
          <p:nvPicPr>
            <p:cNvPr id="78" name="Picture 77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38285" y="8646479"/>
              <a:ext cx="2072820" cy="304826"/>
            </a:xfrm>
            <a:prstGeom prst="rect">
              <a:avLst/>
            </a:prstGeom>
          </p:spPr>
        </p:pic>
        <p:pic>
          <p:nvPicPr>
            <p:cNvPr id="79" name="Picture 78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593422" y="6459311"/>
              <a:ext cx="304826" cy="2072820"/>
            </a:xfrm>
            <a:prstGeom prst="rect">
              <a:avLst/>
            </a:prstGeom>
          </p:spPr>
        </p:pic>
      </p:grpSp>
      <p:grpSp>
        <p:nvGrpSpPr>
          <p:cNvPr id="103" name="Group 102"/>
          <p:cNvGrpSpPr/>
          <p:nvPr/>
        </p:nvGrpSpPr>
        <p:grpSpPr>
          <a:xfrm>
            <a:off x="631561" y="6196646"/>
            <a:ext cx="2663536" cy="2314077"/>
            <a:chOff x="83423" y="6102839"/>
            <a:chExt cx="3278625" cy="2848466"/>
          </a:xfrm>
        </p:grpSpPr>
        <p:grpSp>
          <p:nvGrpSpPr>
            <p:cNvPr id="100" name="Group 99"/>
            <p:cNvGrpSpPr/>
            <p:nvPr/>
          </p:nvGrpSpPr>
          <p:grpSpPr>
            <a:xfrm>
              <a:off x="123127" y="6102839"/>
              <a:ext cx="3238921" cy="2533362"/>
              <a:chOff x="123127" y="6102839"/>
              <a:chExt cx="3238921" cy="2533362"/>
            </a:xfrm>
          </p:grpSpPr>
          <p:pic>
            <p:nvPicPr>
              <p:cNvPr id="98" name="Picture 97"/>
              <p:cNvPicPr>
                <a:picLocks noChangeAspect="1"/>
              </p:cNvPicPr>
              <p:nvPr/>
            </p:nvPicPr>
            <p:blipFill rotWithShape="1">
              <a:blip r:embed="rId9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8249" y="6392852"/>
                <a:ext cx="2567574" cy="2243349"/>
              </a:xfrm>
              <a:prstGeom prst="rect">
                <a:avLst/>
              </a:prstGeom>
            </p:spPr>
          </p:pic>
          <p:sp>
            <p:nvSpPr>
              <p:cNvPr id="99" name="TextBox 98"/>
              <p:cNvSpPr txBox="1"/>
              <p:nvPr/>
            </p:nvSpPr>
            <p:spPr>
              <a:xfrm>
                <a:off x="123127" y="6102839"/>
                <a:ext cx="3238921" cy="29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75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Q-Q plot: Leaf color GWAS p-values</a:t>
                </a:r>
              </a:p>
            </p:txBody>
          </p:sp>
        </p:grpSp>
        <p:pic>
          <p:nvPicPr>
            <p:cNvPr id="101" name="Picture 100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28286" y="8646479"/>
              <a:ext cx="2072820" cy="304826"/>
            </a:xfrm>
            <a:prstGeom prst="rect">
              <a:avLst/>
            </a:prstGeom>
          </p:spPr>
        </p:pic>
        <p:pic>
          <p:nvPicPr>
            <p:cNvPr id="102" name="Picture 101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423" y="6459311"/>
              <a:ext cx="304826" cy="2072820"/>
            </a:xfrm>
            <a:prstGeom prst="rect">
              <a:avLst/>
            </a:prstGeom>
          </p:spPr>
        </p:pic>
      </p:grpSp>
      <p:sp>
        <p:nvSpPr>
          <p:cNvPr id="36" name="TextBox 35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7</a:t>
            </a:r>
          </a:p>
        </p:txBody>
      </p:sp>
    </p:spTree>
    <p:extLst>
      <p:ext uri="{BB962C8B-B14F-4D97-AF65-F5344CB8AC3E}">
        <p14:creationId xmlns:p14="http://schemas.microsoft.com/office/powerpoint/2010/main" val="35794638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48988" y="1221956"/>
            <a:ext cx="2924825" cy="2316322"/>
            <a:chOff x="-3161991" y="2975361"/>
            <a:chExt cx="3600253" cy="285122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-2628900" y="3256362"/>
              <a:ext cx="2512129" cy="221540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-2330429" y="5521763"/>
              <a:ext cx="2072820" cy="304826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-2975292" y="3334595"/>
              <a:ext cx="304826" cy="207282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-3161991" y="2975361"/>
              <a:ext cx="3600253" cy="29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75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Q-Q plot: Hypocotyl color (GY) GWAS p-values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3466463" y="1226331"/>
            <a:ext cx="3018415" cy="2311947"/>
            <a:chOff x="3337410" y="-15268"/>
            <a:chExt cx="3715456" cy="2845844"/>
          </a:xfrm>
        </p:grpSpPr>
        <p:grpSp>
          <p:nvGrpSpPr>
            <p:cNvPr id="11" name="Group 10"/>
            <p:cNvGrpSpPr/>
            <p:nvPr/>
          </p:nvGrpSpPr>
          <p:grpSpPr>
            <a:xfrm>
              <a:off x="3581609" y="260349"/>
              <a:ext cx="2844591" cy="2570227"/>
              <a:chOff x="3581609" y="260349"/>
              <a:chExt cx="2844591" cy="2570227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5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916531" y="260349"/>
                <a:ext cx="2509669" cy="2215002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226472" y="2525750"/>
                <a:ext cx="2072820" cy="304826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81609" y="338582"/>
                <a:ext cx="304826" cy="2072820"/>
              </a:xfrm>
              <a:prstGeom prst="rect">
                <a:avLst/>
              </a:prstGeom>
            </p:spPr>
          </p:pic>
        </p:grpSp>
        <p:sp>
          <p:nvSpPr>
            <p:cNvPr id="12" name="TextBox 11"/>
            <p:cNvSpPr txBox="1"/>
            <p:nvPr/>
          </p:nvSpPr>
          <p:spPr>
            <a:xfrm>
              <a:off x="3337410" y="-15268"/>
              <a:ext cx="3715456" cy="2983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75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Q-Q plot: Hypocotyl color (GR) GWAS p-values</a:t>
              </a: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559222" y="3796482"/>
            <a:ext cx="2633579" cy="2305542"/>
            <a:chOff x="3595045" y="2988630"/>
            <a:chExt cx="3241750" cy="2837959"/>
          </a:xfrm>
        </p:grpSpPr>
        <p:grpSp>
          <p:nvGrpSpPr>
            <p:cNvPr id="16" name="Group 15"/>
            <p:cNvGrpSpPr/>
            <p:nvPr/>
          </p:nvGrpSpPr>
          <p:grpSpPr>
            <a:xfrm>
              <a:off x="3646053" y="2988630"/>
              <a:ext cx="3190742" cy="2497103"/>
              <a:chOff x="3646053" y="2988630"/>
              <a:chExt cx="3190742" cy="2497103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 rotWithShape="1">
              <a:blip r:embed="rId6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903672" y="3229693"/>
                <a:ext cx="2532003" cy="2256040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3646053" y="2988630"/>
                <a:ext cx="3190742" cy="2983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75" b="1" dirty="0">
                    <a:latin typeface="Microsoft Sans Serif" panose="020B0604020202020204" pitchFamily="34" charset="0"/>
                    <a:ea typeface="Microsoft Sans Serif" panose="020B0604020202020204" pitchFamily="34" charset="0"/>
                    <a:cs typeface="Microsoft Sans Serif" panose="020B0604020202020204" pitchFamily="34" charset="0"/>
                  </a:rPr>
                  <a:t>Q-Q plot: Bolting GWAS p-values</a:t>
                </a:r>
              </a:p>
            </p:txBody>
          </p:sp>
        </p:grpSp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39908" y="5521763"/>
              <a:ext cx="2072820" cy="304826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595045" y="3334595"/>
              <a:ext cx="304826" cy="2072820"/>
            </a:xfrm>
            <a:prstGeom prst="rect">
              <a:avLst/>
            </a:prstGeom>
          </p:spPr>
        </p:pic>
      </p:grpSp>
      <p:grpSp>
        <p:nvGrpSpPr>
          <p:cNvPr id="14" name="Group 13"/>
          <p:cNvGrpSpPr/>
          <p:nvPr/>
        </p:nvGrpSpPr>
        <p:grpSpPr>
          <a:xfrm>
            <a:off x="3566077" y="3779704"/>
            <a:ext cx="3018415" cy="2322320"/>
            <a:chOff x="4953000" y="6719272"/>
            <a:chExt cx="5365910" cy="412844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12287" y="7123020"/>
              <a:ext cx="3624496" cy="3232427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4953000" y="6719272"/>
              <a:ext cx="5365910" cy="4308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75" b="1" dirty="0">
                  <a:latin typeface="Microsoft Sans Serif" panose="020B0604020202020204" pitchFamily="34" charset="0"/>
                  <a:ea typeface="Microsoft Sans Serif" panose="020B0604020202020204" pitchFamily="34" charset="0"/>
                  <a:cs typeface="Microsoft Sans Serif" panose="020B0604020202020204" pitchFamily="34" charset="0"/>
                </a:rPr>
                <a:t>Q-Q plot: Cercospora resistance GWAS p-values</a:t>
              </a:r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59906" y="10407482"/>
              <a:ext cx="2993594" cy="440234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128586" y="7248745"/>
              <a:ext cx="440234" cy="2993594"/>
            </a:xfrm>
            <a:prstGeom prst="rect">
              <a:avLst/>
            </a:prstGeom>
          </p:spPr>
        </p:pic>
      </p:grpSp>
      <p:sp>
        <p:nvSpPr>
          <p:cNvPr id="25" name="TextBox 24"/>
          <p:cNvSpPr txBox="1"/>
          <p:nvPr/>
        </p:nvSpPr>
        <p:spPr>
          <a:xfrm>
            <a:off x="-58057" y="-72572"/>
            <a:ext cx="2924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8</a:t>
            </a:r>
          </a:p>
        </p:txBody>
      </p:sp>
    </p:spTree>
    <p:extLst>
      <p:ext uri="{BB962C8B-B14F-4D97-AF65-F5344CB8AC3E}">
        <p14:creationId xmlns:p14="http://schemas.microsoft.com/office/powerpoint/2010/main" val="3461723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313</Words>
  <Application>Microsoft Office PowerPoint</Application>
  <PresentationFormat>A4 Paper (210x297 mm)</PresentationFormat>
  <Paragraphs>90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Microsoft Sans Serif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iman, Amar Singh</dc:creator>
  <cp:lastModifiedBy>Nazgol Emrani</cp:lastModifiedBy>
  <cp:revision>82</cp:revision>
  <dcterms:created xsi:type="dcterms:W3CDTF">2023-12-06T15:47:28Z</dcterms:created>
  <dcterms:modified xsi:type="dcterms:W3CDTF">2024-09-20T09:17:38Z</dcterms:modified>
</cp:coreProperties>
</file>